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6.wmf" ContentType="image/x-wmf"/>
  <Override PartName="/ppt/media/image7.wmf" ContentType="image/x-wmf"/>
  <Override PartName="/ppt/media/image8.wmf" ContentType="image/x-wmf"/>
  <Override PartName="/ppt/media/image9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81800" cy="99187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816058-84DA-4093-9BEA-AFAEF91695E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5BA3CF-9AFF-475D-8E92-C6B77851CD9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E9335B-CCB7-45DB-8A87-6CDBE8092D0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7C9A84-5752-4111-924E-AC3D2F97542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EFDD2C-7E78-4805-931F-824137EFAB3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606BF3-94CA-41F5-867E-8F69475A373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450152-BD66-44C8-90F6-75547A3B13F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99C132-B0C3-4D9F-8BB4-57026452E9A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C05A5A-BE8A-4927-8A5C-7888C8A8D5D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64806E-9D36-4BAC-9AD3-396B2B9066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3207D1-EFEC-4C19-B275-9CB98B5F20B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01C458-091F-4B7A-841D-79E554A36E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3DF7885-052E-41A8-9392-B6B12D3480F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image" Target="../media/image7.wmf"/><Relationship Id="rId8" Type="http://schemas.openxmlformats.org/officeDocument/2006/relationships/image" Target="../media/image8.wmf"/><Relationship Id="rId9" Type="http://schemas.openxmlformats.org/officeDocument/2006/relationships/image" Target="../media/image9.wmf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20065" t="11106" r="0" b="14742"/>
          <a:stretch/>
        </p:blipFill>
        <p:spPr>
          <a:xfrm>
            <a:off x="1360440" y="1390680"/>
            <a:ext cx="1511280" cy="135720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rcRect l="11844" t="12138" r="0" b="16576"/>
          <a:stretch/>
        </p:blipFill>
        <p:spPr>
          <a:xfrm>
            <a:off x="1322280" y="3327480"/>
            <a:ext cx="2021040" cy="117468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3"/>
          <a:srcRect l="11783" t="11984" r="0" b="15624"/>
          <a:stretch/>
        </p:blipFill>
        <p:spPr>
          <a:xfrm>
            <a:off x="1316160" y="4565520"/>
            <a:ext cx="2031840" cy="1198800"/>
          </a:xfrm>
          <a:prstGeom prst="rect">
            <a:avLst/>
          </a:prstGeom>
          <a:ln w="0">
            <a:noFill/>
          </a:ln>
        </p:spPr>
      </p:pic>
      <p:pic>
        <p:nvPicPr>
          <p:cNvPr id="44" name="" descr=""/>
          <p:cNvPicPr/>
          <p:nvPr/>
        </p:nvPicPr>
        <p:blipFill>
          <a:blip r:embed="rId4"/>
          <a:srcRect l="11874" t="12768" r="0" b="15834"/>
          <a:stretch/>
        </p:blipFill>
        <p:spPr>
          <a:xfrm>
            <a:off x="1316160" y="5821200"/>
            <a:ext cx="2027160" cy="1181160"/>
          </a:xfrm>
          <a:prstGeom prst="rect">
            <a:avLst/>
          </a:prstGeom>
          <a:ln w="0">
            <a:noFill/>
          </a:ln>
        </p:spPr>
      </p:pic>
      <p:pic>
        <p:nvPicPr>
          <p:cNvPr id="45" name="" descr=""/>
          <p:cNvPicPr/>
          <p:nvPr/>
        </p:nvPicPr>
        <p:blipFill>
          <a:blip r:embed="rId5"/>
          <a:srcRect l="12085" t="12558" r="0" b="15456"/>
          <a:stretch/>
        </p:blipFill>
        <p:spPr>
          <a:xfrm>
            <a:off x="3475080" y="3336840"/>
            <a:ext cx="2022480" cy="1182600"/>
          </a:xfrm>
          <a:prstGeom prst="rect">
            <a:avLst/>
          </a:prstGeom>
          <a:ln w="0">
            <a:noFill/>
          </a:ln>
        </p:spPr>
      </p:pic>
      <p:pic>
        <p:nvPicPr>
          <p:cNvPr id="46" name="" descr=""/>
          <p:cNvPicPr/>
          <p:nvPr/>
        </p:nvPicPr>
        <p:blipFill>
          <a:blip r:embed="rId6"/>
          <a:srcRect l="11995" t="12600" r="0" b="16128"/>
          <a:stretch/>
        </p:blipFill>
        <p:spPr>
          <a:xfrm>
            <a:off x="1328760" y="7051680"/>
            <a:ext cx="2031840" cy="1185840"/>
          </a:xfrm>
          <a:prstGeom prst="rect">
            <a:avLst/>
          </a:prstGeom>
          <a:ln w="0">
            <a:noFill/>
          </a:ln>
        </p:spPr>
      </p:pic>
      <p:pic>
        <p:nvPicPr>
          <p:cNvPr id="47" name="" descr=""/>
          <p:cNvPicPr/>
          <p:nvPr/>
        </p:nvPicPr>
        <p:blipFill>
          <a:blip r:embed="rId7"/>
          <a:srcRect l="11924" t="12544" r="0" b="15722"/>
          <a:stretch/>
        </p:blipFill>
        <p:spPr>
          <a:xfrm>
            <a:off x="3473280" y="5824440"/>
            <a:ext cx="2027520" cy="1181160"/>
          </a:xfrm>
          <a:prstGeom prst="rect">
            <a:avLst/>
          </a:prstGeom>
          <a:ln w="0">
            <a:noFill/>
          </a:ln>
        </p:spPr>
      </p:pic>
      <p:pic>
        <p:nvPicPr>
          <p:cNvPr id="48" name="" descr=""/>
          <p:cNvPicPr/>
          <p:nvPr/>
        </p:nvPicPr>
        <p:blipFill>
          <a:blip r:embed="rId8"/>
          <a:srcRect l="11924" t="12866" r="0" b="16016"/>
          <a:stretch/>
        </p:blipFill>
        <p:spPr>
          <a:xfrm>
            <a:off x="3475080" y="4578480"/>
            <a:ext cx="2022480" cy="1184040"/>
          </a:xfrm>
          <a:prstGeom prst="rect">
            <a:avLst/>
          </a:prstGeom>
          <a:ln w="0">
            <a:noFill/>
          </a:ln>
        </p:spPr>
      </p:pic>
      <p:pic>
        <p:nvPicPr>
          <p:cNvPr id="49" name="" descr=""/>
          <p:cNvPicPr/>
          <p:nvPr/>
        </p:nvPicPr>
        <p:blipFill>
          <a:blip r:embed="rId9"/>
          <a:srcRect l="11914" t="11788" r="0" b="15806"/>
          <a:stretch/>
        </p:blipFill>
        <p:spPr>
          <a:xfrm>
            <a:off x="3468600" y="7034040"/>
            <a:ext cx="2030400" cy="1200240"/>
          </a:xfrm>
          <a:prstGeom prst="rect">
            <a:avLst/>
          </a:prstGeom>
          <a:ln w="0">
            <a:noFill/>
          </a:ln>
        </p:spPr>
      </p:pic>
      <p:sp>
        <p:nvSpPr>
          <p:cNvPr id="50" name=""/>
          <p:cNvSpPr/>
          <p:nvPr/>
        </p:nvSpPr>
        <p:spPr>
          <a:xfrm>
            <a:off x="1230120" y="8180280"/>
            <a:ext cx="2169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0</a:t>
            </a: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0                 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0</a:t>
            </a: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         10</a:t>
            </a: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          10</a:t>
            </a: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3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        10</a:t>
            </a: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3353760" y="8180280"/>
            <a:ext cx="2226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0</a:t>
            </a: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0                 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0</a:t>
            </a: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           10</a:t>
            </a: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          10</a:t>
            </a: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3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        10</a:t>
            </a: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155960" y="808524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102680" y="781056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4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1099440" y="752328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8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1045800" y="724068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2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1050480" y="696600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7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1155960" y="68500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1102680" y="657540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4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1099440" y="628812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8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1045800" y="600552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2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1050480" y="574056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7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1155960" y="56134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1102680" y="533880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4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1099440" y="505152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8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1045800" y="476892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2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1050480" y="450360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7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1155960" y="437184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1102680" y="409716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4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1099440" y="380988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8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1045800" y="352728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2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1050480" y="326232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7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1370160" y="8450280"/>
            <a:ext cx="39589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 flipV="1">
            <a:off x="1009800" y="3481200"/>
            <a:ext cx="0" cy="45766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3021480" y="8545680"/>
            <a:ext cx="621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FL4-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 rot="16200000">
            <a:off x="425880" y="5617440"/>
            <a:ext cx="646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Coun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309960" y="320760"/>
            <a:ext cx="19364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</a:rPr>
              <a:t>Additional file 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1221120" y="25923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1109160" y="226548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25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1107720" y="164628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76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1049400" y="1322280"/>
            <a:ext cx="406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02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1109160" y="195264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51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1310040" y="269712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1599840" y="269892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25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2301480" y="269712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76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2593800" y="2697120"/>
            <a:ext cx="406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02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1937880" y="269892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51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 rot="16200000">
            <a:off x="810720" y="1838520"/>
            <a:ext cx="46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S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1879200" y="2841480"/>
            <a:ext cx="468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FS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2565000" y="3419640"/>
            <a:ext cx="45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IgG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2571120" y="5857920"/>
            <a:ext cx="526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IgG2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2559240" y="7081920"/>
            <a:ext cx="682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anti-AU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4712760" y="4662360"/>
            <a:ext cx="729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anti-M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2569320" y="4665600"/>
            <a:ext cx="520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IgG2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4700880" y="3421080"/>
            <a:ext cx="766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anti-ACE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4701960" y="5851440"/>
            <a:ext cx="625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anti-Ax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4704120" y="7086600"/>
            <a:ext cx="77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anti-PDP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215280" y="1114560"/>
            <a:ext cx="4503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</a:rPr>
              <a:t>A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230040" y="3059280"/>
            <a:ext cx="4352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</a:rPr>
              <a:t>B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3-22T16:00:37Z</dcterms:created>
  <dc:creator>Stefan Poehlmann</dc:creator>
  <dc:description/>
  <dc:language>en-US</dc:language>
  <cp:lastModifiedBy>Stefan Poehlmann</cp:lastModifiedBy>
  <dcterms:modified xsi:type="dcterms:W3CDTF">2010-04-01T12:32:14Z</dcterms:modified>
  <cp:revision>5</cp:revision>
  <dc:subject/>
  <dc:title>Folie 1</dc:title>
</cp:coreProperties>
</file>